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772400" cy="1005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9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3E85090-18D1-4B4E-9824-A82D8176379F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6"/>
          <p:cNvSpPr/>
          <p:nvPr/>
        </p:nvSpPr>
        <p:spPr>
          <a:xfrm>
            <a:off x="439884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36AFD15D-4D3B-454A-AFC1-BC63948E85E3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77760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21D8EE6-A61B-46A1-8F30-B41F8DCEBFE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CEDE70-B5E4-4802-94AC-338EB68A21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09F3058-6F45-4A3F-B6D5-AFC1FE9DE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1ED6352-54A1-4EA5-87C9-46E9E09892B2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ED3A884-1E1C-4642-B3D3-04C78274B2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D724E24-5FE8-4702-8F8E-4FB2E35A71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C792F6-B138-4C90-A0A9-A9CF144FBB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9A4190-44FE-4081-BB47-4A8DE97B72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A1FEB14-5B3A-4F2F-BC54-CEEC67C193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D27DE19-CE22-47DA-9950-478AC65C81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6B84D42-E02E-4DE2-B6E1-E1E5440D8E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41B3258-B77B-4D1B-944A-B8785DCD96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Text Box 2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9CDE0C96-7C8B-40D2-BA0A-4DACF2A0976C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0" y="257040"/>
            <a:ext cx="91440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ble S1. Gene sequence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Isp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from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Metrosideros polymorph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523800" y="853920"/>
          <a:ext cx="8097840" cy="5749920"/>
        </p:xfrm>
        <a:graphic>
          <a:graphicData uri="http://schemas.openxmlformats.org/drawingml/2006/table">
            <a:tbl>
              <a:tblPr/>
              <a:tblGrid>
                <a:gridCol w="1716120"/>
                <a:gridCol w="6381720"/>
              </a:tblGrid>
              <a:tr h="457200">
                <a:tc>
                  <a:txBody>
                    <a:bodyPr lIns="90000" rIns="90000" tIns="6156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156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 (5’-3’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46360">
                <a:tc>
                  <a:txBody>
                    <a:bodyPr lIns="90000" rIns="90000" tIns="6156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iginal sequence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2920" bIns="4680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TTCCGCGAGCACGCAGGTCTCTGATCCTCAAGAAGGACGAAGATCGGCCAACTATCAGCCATCTGTCTGGACTTACAATTACCTTCAGTCCCTTGTGGCCGATGAAGGTCGTCGATCTCATCGCGAGGTTGAGCTACAGAGAGAAAAGGCACAAGTGTTGGAAGAAGAAGTGAGAGGTGCTCTCAATGATGAAAAGGCTGAACCCACGACCATATTTGCTCTGGTTGATGACATTCGACGCTTAGGATTGGGACATCAATTTGAGGAAGACATTTCAAGAGCTCTTCGCAGATGTCTCTCTCCGGGAGCGGTCAATAAGAGCCTAGACAAGTCTCTGCATGGCACAGCTCTCGGCTTTCGGATTCTTAGACAGCATGGCTTTGCTGTTTCTCAAGATGTTTTAAAGATTTTCATGGACGAAAGTGGCAGTTTTATGAAGACCCTTGGTGGTGATGTCCAAGGTATGCTTAGTCTATACGAAGCCTCCCATTTGGCATTCGAAGAAGAAGACATCTTGCACCAGGCTAAAACATTCTCCATCGAGCATCTCAAAAGCCTTAGTCGTGACATTAGCAAAGATCTTCAAGACCTAGTGAACCATGAACTGGAGCTGCCTCTGCACCGTAGAATGCCATTGCTAGAAGCTCGACGGTCTATCGAAGCTTATAGCAAACGTGGATACATGAATGATCGAATCCTCAAACTCGCCGCAACGAACTTCAACACGTCGCAATCAATCCTCCAAAGAGATCTTCAGGAAATGTTAGGATGGTGGAACAATGTTAGCCTTGCAAAAAGGTTGAGCTTTGCGAGGGATAGATTGATGGAGTGCTTCTTTTGGGCGGTTGGAATTGCAAATGAGCCTCTGCTCAGTAATTGTCGGAAAGGGGTGACCAAAGCGTTTGCGCTGATCCTTGTCCTCGATGATGTGTACGATGTTTTCGGCACATTGGACGAATTGGAGCTATTCACAGACGCTGTTCGCAGATGGGACCTCAATGCTGTGGAAGATCTTCCTGCCTATATGAAGTTGTGCTACTTAGCTCTCTACAACAACGTGAACGAGATGGCTTACGACACTCTCAAGGAGACTGGTGAAAACGTCATCTTGTATCTAGCCAAAGCGTGGTATGACTTGTGCAAAGCCTTCTTGCAAGAAGCAAAATGGAGTTACAACAAGATCATCCCAGGAGTTGAAGAGTACTTGAACAATGGGTGGATGTCGTCGTCAGGGCAGGTCATGTTGACTCATGCCTACTTTTTAGCAAGCCCAAGCATGAGAAAGGAGGAACTTGAATCCCTAGAACATTACCATGATCTCTTGCGGTTGCCGTCCTTGATTTTCCGTCTTACCAATGATCTCGCTTCCTCATCGGCTGAGCTAGAGAGGGGAGAGACGACAAATTCAATACAGAGTTACATGCAAGAAAATGGGATCTCCGAGTCAGAGGCTCGAGAGTACGTTACTGAACAGATCGACACGGCGTGGAAAAAGATGAACAAATATCTAGTGGATCACTCGACTTTCGATCAATCTTTTGTGCGGATGGCTTATAACCTTGCCAGGATGGCGCATTGTGTGTACCAAGATGGAGATGCGATTGGAGCTCCGGACGATCAGTCGTGGAATCGTGTGCATTCCTTGATAATCTCGCCCGTCTCTCTTGCCCCACGTT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46360">
                <a:tc>
                  <a:txBody>
                    <a:bodyPr lIns="90000" rIns="90000" tIns="6156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. coli 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don optimized sequenc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2920" bIns="46800" anchor="t">
                      <a:noAutofit/>
                    </a:bodyPr>
                    <a:p>
                      <a:pPr algn="just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6515280"/>
                          <a:tab algn="l" pos="7238880"/>
                          <a:tab algn="l" pos="796284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TAGTGCTTCCACACAAGTCAGTGACCCGCAGGAAGGACGCCGCAGCGCTAACTACCAACCCTCAGTGTGGACCTACAACTACTTACAATCCCTTGTTGCTGACGAGGGTCGTCGTAGCCACCGCGAAGTAGAGTTGCAGCGTGAGAAAGCACAAGTCTTGGAGGAGGAAGTTCGTGGTGCGCTTAACGACGAAAAGGCGGAGCCAACCACTATTTTTGCACTGGTAGACGATATCCGCCGCTTGGGTCTTGGTCATCAGTTCGAGGAGGATATCAGTCGTGCGCTTCGTCGTTGTCTGAGTCCGGGTGCCGTAAACAAGAGCTTGGATAAGTCGCTTCATGGGACTGCCTTAGGCTTCCGTATTCTGCGTCAACACGGATTCGCAGTTAGCCAGGATGTTCTTAAAATTTTCATGGATGAGAGCGGCAGTTTTATGAAGACCTTGGGTGGTGATGTCCAGGGAATGCTGAGTTTATATGAGGCGTCACATCTGGCATTTGAGGAAGAGGATATCTTACATCAGGCAAAAACGTTTTCCATCGAACACCTGAAGTCCTTGTCGCGTGACATCAGTAAAGATTTACAAGACCTGGTCAATCACGAACTTGAGCTTCCCCTTCATCGTCGCATGCCACTGTTGGAAGCCCGCCGCTCGATTGAGGCTTACTCTAAGCGTGGCTATATGAATGATCGCATCTTGAAGTTAGCAGCGACCAATTTCAACACGTCTCAATCAATTCTTCAACGCGATCTGCAAGAAATGCTGGGTTGGTGGAACAATGTCTCTTTAGCGAAACGTTTGAGTTTCGCACGCGATCGCCTGATGGAATGCTTTTTCTGGGCGGTTGGAATTGCTAACGAGCCATTGCTTTCAAACTGCCGCAAAGGAGTGACTAAGGCATTCGCGCTGATTTTAGTGTTGGATGATGTATATGATGTTTTCGGAACCCTGGATGAACTTGAACTTTTCACAGATGCAGTGCGCCGTTGGGATTTGAACGCTGTAGAGGATCTGCCAGCATACATGAAACTTTGTTATCTGGCCTTGTATAACAATGTTAATGAAATGGCCTATGATACACTTAAAGAAACGGGAGAGAATGTTATCTTGTACCTTGCAAAGGCGTGGTACGATCTGTGTAAGGCATTCTTACAGGAAGCGAAGTGGAGCTACAACAAAATCATCCCTGGCGTAGAAGAGTACTTGAATAATGGGTGGATGTCTTCTTCTGGCCAGGTAATGTTAACGCACGCTTACTTTTTGGCTTCCCCCTCCATGCGTAAGGAGGAGCTTGAGTCTTTAGAACACTATCACGACCTTCTTCGCCTTCCATCCTTAATTTTTCGTTTAACTAACGACCTGGCCTCTTCTTCTGCTGAACTTGAGCGTGGCGAGACGACTAATTCCATTCAGAGCTATATGCAGGAAAACGGTATCAGTGAGTCTGAAGCCCGCGAGTACGTCACCGAGCAGATTGACACCGCGTGGAAAAAGATGAACAAGTACCTGGTGGATCACTCCACATTCGATCAATCATTCGTTCGTATGGCATATAACTTAGCACGTATGGCCCATTGTGTGTATCAAGATGGGGATGCCATTGGAGCGCCAGACGATCAATCTTGGAACCGCGTACACAGTTTGATCATTTCACCCGTCAGTCTTGCGCCGCGTT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Jerrick  Rivas</cp:lastModifiedBy>
  <dcterms:modified xsi:type="dcterms:W3CDTF">2018-06-13T05:55:30Z</dcterms:modified>
  <cp:revision>1</cp:revision>
  <dc:subject/>
  <dc:title>PowerPoint Presentation</dc:title>
</cp:coreProperties>
</file>